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81" d="100"/>
          <a:sy n="81" d="100"/>
        </p:scale>
        <p:origin x="46" y="17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9DC9C7-1D81-441B-B3EF-59355A76E3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44F02B-09AD-4D86-8D1B-DF84B3EDCA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AEC00B-E465-4414-B8A1-6632A9A38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81AE-6BE1-40C6-A248-4103D4B77044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738ABC-A0DE-4787-920A-9C5EDF72B6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4CBC02-86D5-46B7-81CA-58283E5498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56669-A69A-4C8A-A5F5-564FC90B4B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8633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6413D0-C2EF-4FA3-874B-A03901A325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E95292-6D5C-4E56-B706-4C584DD4DC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0AA0BD-331D-4B53-95B0-6A5FBF25A4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81AE-6BE1-40C6-A248-4103D4B77044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A31DAC-40D7-40BB-9155-0EBBE7084C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BB1760-871F-4D2C-859D-B9C8D1C603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56669-A69A-4C8A-A5F5-564FC90B4B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4246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9BF9D4C-02F2-432D-935F-AECAA82EFE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4B7B26-ECC6-451E-8764-299E957B10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1DB987-C2B6-474F-8ABC-395678B962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81AE-6BE1-40C6-A248-4103D4B77044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2BE130-8AC1-4270-9E2C-23BCBE06B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51F9B0-97A7-44BB-8D6C-4AEDB9B5C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56669-A69A-4C8A-A5F5-564FC90B4B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8890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A74064-95A9-4D52-B53D-498B24A002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3D4FE9-816F-4C9D-8A90-22DD73AC3A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836E04-75E8-4C14-B921-C3E64A6D43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81AE-6BE1-40C6-A248-4103D4B77044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90269B-E71B-47F1-88D5-2C8469A81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1EE004-6742-4A69-BF0B-92E339F45C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56669-A69A-4C8A-A5F5-564FC90B4B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1125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2FD40E-9CF3-4B5D-8588-489E23B877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F671F9-F692-4F73-9623-C2A52B0D6B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BED082-26F8-4BFA-BC45-8ED66A6180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81AE-6BE1-40C6-A248-4103D4B77044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345B56-474E-4890-AA78-8BC5EA20DE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4E14D7-6BE0-4C1C-906C-6AA049A76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56669-A69A-4C8A-A5F5-564FC90B4B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4894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8BA8F0-3115-44A8-9FBD-5176F787DB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0FCFA4-0D81-423E-9927-D07BE942B6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CF0A62-8AC6-4087-B3D7-D6DEE0C307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D42299-F016-483B-9E37-AD5B0B31B9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81AE-6BE1-40C6-A248-4103D4B77044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2555E7-F5B5-4C33-ADEF-144C16219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80E241-21C1-41A6-9224-BEAC1B8FE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56669-A69A-4C8A-A5F5-564FC90B4B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7467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1A7BC3-B987-49EF-96BB-03B0D1FE41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753BE2-9029-4B61-9535-BE904248A3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BCE319-533A-4CFD-9561-7BB8635F08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6A731D1-7BDA-4928-9601-74F791AEE7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E6B026F-DCF5-41CB-801D-B711437CE9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3A096D-219B-4590-ACA9-90CB922FDC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81AE-6BE1-40C6-A248-4103D4B77044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6A286B5-4C7E-4994-915C-9422F833FF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F13A8F-3064-416C-8ACA-471871D41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56669-A69A-4C8A-A5F5-564FC90B4B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1003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27B5AE-6C40-46E2-B0E1-C378B29951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DE9F5D2-720C-41C0-BB5C-68D73EC289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81AE-6BE1-40C6-A248-4103D4B77044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DC0AD8E-7D51-44AE-B446-98E07E563D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0FFE272-8437-4E9E-B07D-A5F16B1E58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56669-A69A-4C8A-A5F5-564FC90B4B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1702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76CD704-1ED6-447F-8F49-1161171F9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81AE-6BE1-40C6-A248-4103D4B77044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05BC815-AFEB-4155-864F-93334B2DB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AAA247-FDDC-4915-A084-209099D9B6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56669-A69A-4C8A-A5F5-564FC90B4B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0173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589380-5AB4-4190-9465-3DF4722AD2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240B0B-B9C9-468A-BC14-F40AF456DC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F530A0-0DEA-451E-9C68-59D6DFFDD5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411BF8-B6C6-46E0-B6CC-AD586B197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81AE-6BE1-40C6-A248-4103D4B77044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2F1E8C-0145-47EA-9924-0D466CFF3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33C2C2-1068-4584-866C-AE849B723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56669-A69A-4C8A-A5F5-564FC90B4B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023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4608DC-33A2-43DA-8AFE-1F1737F521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294C173-FCC2-439D-A21A-AE9A9F940E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95FFDC-F156-41A6-A4E8-1025BA0AFA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B55E22-64EF-46C9-99CA-4B7B2ADC13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581AE-6BE1-40C6-A248-4103D4B77044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34E91B-7384-4001-A8DB-8F44B4896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C3EE11-50F5-4CA0-AAD4-B7DD23A610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56669-A69A-4C8A-A5F5-564FC90B4B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203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1CA616D-3DF5-4733-9B36-120A02D3E7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3DCE9C-42C3-41F2-AACF-680A57AF16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97A59E-C308-4692-B239-37805BC7E4A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8581AE-6BE1-40C6-A248-4103D4B77044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6B0F0B-68BD-49CA-B547-1833A4C255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C11756-0353-4D2F-9C3F-4DEC757A20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056669-A69A-4C8A-A5F5-564FC90B4B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8411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7" Type="http://schemas.openxmlformats.org/officeDocument/2006/relationships/image" Target="../media/image8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sv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B01013-1CAC-4299-9B5C-F55145393544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Fig 6D</a:t>
            </a:r>
            <a:endParaRPr lang="en-GB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07E712C-38C7-41EC-AFBD-D0FBAC074826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25950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8FEE9E72-075D-4183-B5D4-2440E79BC2A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-722" t="12517" r="19488" b="66650"/>
          <a:stretch/>
        </p:blipFill>
        <p:spPr>
          <a:xfrm>
            <a:off x="2856050" y="2162454"/>
            <a:ext cx="6098915" cy="1182566"/>
          </a:xfrm>
          <a:prstGeom prst="rect">
            <a:avLst/>
          </a:prstGeom>
        </p:spPr>
      </p:pic>
      <p:pic>
        <p:nvPicPr>
          <p:cNvPr id="3" name="Picture 2" descr="A picture containing text, electronics, white&#10;&#10;Description automatically generated">
            <a:extLst>
              <a:ext uri="{FF2B5EF4-FFF2-40B4-BE49-F238E27FC236}">
                <a16:creationId xmlns:a16="http://schemas.microsoft.com/office/drawing/2014/main" id="{04E2B1EA-B44B-4D48-BEDE-309BF68105E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129" t="26520" r="-2132" b="58467"/>
          <a:stretch/>
        </p:blipFill>
        <p:spPr>
          <a:xfrm>
            <a:off x="3001122" y="5108511"/>
            <a:ext cx="7411915" cy="731521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FB8092C1-AFB9-41F3-8D5B-2D5071A8AD36}"/>
              </a:ext>
            </a:extLst>
          </p:cNvPr>
          <p:cNvSpPr/>
          <p:nvPr/>
        </p:nvSpPr>
        <p:spPr>
          <a:xfrm>
            <a:off x="4430598" y="2162454"/>
            <a:ext cx="4473018" cy="1301897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F797F8C-21D6-4B16-B967-C054A17B7881}"/>
              </a:ext>
            </a:extLst>
          </p:cNvPr>
          <p:cNvSpPr/>
          <p:nvPr/>
        </p:nvSpPr>
        <p:spPr>
          <a:xfrm>
            <a:off x="4053995" y="4735961"/>
            <a:ext cx="4473018" cy="1301897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18BFC5A-556A-4800-8DD6-C0C8B2DBD7E5}"/>
              </a:ext>
            </a:extLst>
          </p:cNvPr>
          <p:cNvSpPr txBox="1"/>
          <p:nvPr/>
        </p:nvSpPr>
        <p:spPr>
          <a:xfrm>
            <a:off x="1925515" y="1559789"/>
            <a:ext cx="1788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l #1 </a:t>
            </a:r>
            <a:r>
              <a:rPr lang="en-US" dirty="0" err="1"/>
              <a:t>pAkt</a:t>
            </a:r>
            <a:r>
              <a:rPr lang="en-US" dirty="0"/>
              <a:t> T308</a:t>
            </a:r>
            <a:endParaRPr lang="en-GB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7AA2527-EBB6-4514-902B-01A5F6374635}"/>
              </a:ext>
            </a:extLst>
          </p:cNvPr>
          <p:cNvSpPr txBox="1"/>
          <p:nvPr/>
        </p:nvSpPr>
        <p:spPr>
          <a:xfrm>
            <a:off x="2130668" y="4541353"/>
            <a:ext cx="16541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l #2 Total Akt</a:t>
            </a:r>
            <a:endParaRPr lang="en-GB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C956E5C-9A8B-4E86-B6DD-9FF0824C7D4F}"/>
              </a:ext>
            </a:extLst>
          </p:cNvPr>
          <p:cNvSpPr txBox="1"/>
          <p:nvPr/>
        </p:nvSpPr>
        <p:spPr>
          <a:xfrm>
            <a:off x="593481" y="726711"/>
            <a:ext cx="2967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opped area indicated in red</a:t>
            </a:r>
            <a:endParaRPr lang="en-GB" dirty="0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B79675BD-6A89-4C6F-8CE7-6BE4A9EEF273}"/>
              </a:ext>
            </a:extLst>
          </p:cNvPr>
          <p:cNvCxnSpPr/>
          <p:nvPr/>
        </p:nvCxnSpPr>
        <p:spPr>
          <a:xfrm>
            <a:off x="4053995" y="1529862"/>
            <a:ext cx="0" cy="5407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91C154FB-F29C-40E2-8AAD-24DE631837A5}"/>
              </a:ext>
            </a:extLst>
          </p:cNvPr>
          <p:cNvSpPr txBox="1"/>
          <p:nvPr/>
        </p:nvSpPr>
        <p:spPr>
          <a:xfrm>
            <a:off x="3873012" y="1213566"/>
            <a:ext cx="2278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os control </a:t>
            </a:r>
            <a:r>
              <a:rPr lang="en-US" dirty="0" err="1"/>
              <a:t>hela</a:t>
            </a:r>
            <a:r>
              <a:rPr lang="en-US" dirty="0"/>
              <a:t> lysate</a:t>
            </a:r>
            <a:endParaRPr lang="en-GB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B9197A2-0954-45F6-AC36-29583CB24C23}"/>
              </a:ext>
            </a:extLst>
          </p:cNvPr>
          <p:cNvSpPr txBox="1"/>
          <p:nvPr/>
        </p:nvSpPr>
        <p:spPr>
          <a:xfrm>
            <a:off x="8647836" y="4334734"/>
            <a:ext cx="2278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os control </a:t>
            </a:r>
            <a:r>
              <a:rPr lang="en-US" dirty="0" err="1"/>
              <a:t>hela</a:t>
            </a:r>
            <a:r>
              <a:rPr lang="en-US" dirty="0"/>
              <a:t> lysate</a:t>
            </a:r>
            <a:endParaRPr lang="en-GB" dirty="0"/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BF932BFB-55E3-41A8-B9E1-CAF07ED16BF5}"/>
              </a:ext>
            </a:extLst>
          </p:cNvPr>
          <p:cNvCxnSpPr/>
          <p:nvPr/>
        </p:nvCxnSpPr>
        <p:spPr>
          <a:xfrm>
            <a:off x="8870714" y="4541353"/>
            <a:ext cx="0" cy="5407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A2DE3DAD-112D-40ED-B0BC-C5B31E9B8A48}"/>
              </a:ext>
            </a:extLst>
          </p:cNvPr>
          <p:cNvSpPr txBox="1"/>
          <p:nvPr/>
        </p:nvSpPr>
        <p:spPr>
          <a:xfrm>
            <a:off x="5928122" y="1789010"/>
            <a:ext cx="1477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perm lysates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4297AEE-AFD1-4BD2-84ED-875A87A73DDB}"/>
              </a:ext>
            </a:extLst>
          </p:cNvPr>
          <p:cNvSpPr txBox="1"/>
          <p:nvPr/>
        </p:nvSpPr>
        <p:spPr>
          <a:xfrm>
            <a:off x="5711245" y="4334734"/>
            <a:ext cx="1477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perm lysates</a:t>
            </a:r>
            <a:endParaRPr lang="en-GB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79103C7-9131-4484-A59F-6A316A7EB1CD}"/>
              </a:ext>
            </a:extLst>
          </p:cNvPr>
          <p:cNvSpPr txBox="1"/>
          <p:nvPr/>
        </p:nvSpPr>
        <p:spPr>
          <a:xfrm>
            <a:off x="593481" y="262965"/>
            <a:ext cx="1796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 6D– Akt blots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405538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7F7E2A45-8093-45A7-B5F6-6EBCD40A81AB}"/>
              </a:ext>
            </a:extLst>
          </p:cNvPr>
          <p:cNvSpPr txBox="1"/>
          <p:nvPr/>
        </p:nvSpPr>
        <p:spPr>
          <a:xfrm>
            <a:off x="593481" y="262965"/>
            <a:ext cx="54746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 6D– </a:t>
            </a:r>
            <a:r>
              <a:rPr lang="en-US" b="1" dirty="0" err="1"/>
              <a:t>pPKA</a:t>
            </a:r>
            <a:r>
              <a:rPr lang="en-US" b="1" dirty="0"/>
              <a:t> substrate (top) and His (middle) and  blots</a:t>
            </a:r>
            <a:endParaRPr lang="en-GB" b="1" dirty="0"/>
          </a:p>
        </p:txBody>
      </p:sp>
      <p:pic>
        <p:nvPicPr>
          <p:cNvPr id="12" name="Graphic 11">
            <a:extLst>
              <a:ext uri="{FF2B5EF4-FFF2-40B4-BE49-F238E27FC236}">
                <a16:creationId xmlns:a16="http://schemas.microsoft.com/office/drawing/2014/main" id="{CBBBD7B1-DAE2-46A7-8501-451CE3E990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502177" y="5946203"/>
            <a:ext cx="7419534" cy="775108"/>
          </a:xfrm>
          <a:prstGeom prst="rect">
            <a:avLst/>
          </a:prstGeom>
        </p:spPr>
      </p:pic>
      <p:pic>
        <p:nvPicPr>
          <p:cNvPr id="14" name="Graphic 13">
            <a:extLst>
              <a:ext uri="{FF2B5EF4-FFF2-40B4-BE49-F238E27FC236}">
                <a16:creationId xmlns:a16="http://schemas.microsoft.com/office/drawing/2014/main" id="{C92DF673-2D17-4EB6-8FD4-14A65E8884D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3782315" y="4740942"/>
            <a:ext cx="5147723" cy="833786"/>
          </a:xfrm>
          <a:prstGeom prst="rect">
            <a:avLst/>
          </a:prstGeom>
        </p:spPr>
      </p:pic>
      <p:pic>
        <p:nvPicPr>
          <p:cNvPr id="16" name="Graphic 15">
            <a:extLst>
              <a:ext uri="{FF2B5EF4-FFF2-40B4-BE49-F238E27FC236}">
                <a16:creationId xmlns:a16="http://schemas.microsoft.com/office/drawing/2014/main" id="{D49DBD6C-EB11-4F94-9C16-D81261D93B6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3782315" y="804551"/>
            <a:ext cx="5147722" cy="35048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6427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</TotalTime>
  <Words>49</Words>
  <Application>Microsoft Office PowerPoint</Application>
  <PresentationFormat>Widescreen</PresentationFormat>
  <Paragraphs>1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Fig 6D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6D</dc:title>
  <dc:creator>Pradipta Ghosh</dc:creator>
  <cp:lastModifiedBy>Pradipta Ghosh</cp:lastModifiedBy>
  <cp:revision>5</cp:revision>
  <dcterms:created xsi:type="dcterms:W3CDTF">2021-04-27T19:41:39Z</dcterms:created>
  <dcterms:modified xsi:type="dcterms:W3CDTF">2021-04-27T22:17:58Z</dcterms:modified>
</cp:coreProperties>
</file>